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-258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73681-D65B-4678-B6AC-8D971C9B6FD5}" type="datetimeFigureOut">
              <a:rPr lang="en-US" smtClean="0"/>
              <a:pPr/>
              <a:t>4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27ECF-7177-4476-A5A5-B01210BFE3C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73681-D65B-4678-B6AC-8D971C9B6FD5}" type="datetimeFigureOut">
              <a:rPr lang="en-US" smtClean="0"/>
              <a:pPr/>
              <a:t>4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27ECF-7177-4476-A5A5-B01210BFE3C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73681-D65B-4678-B6AC-8D971C9B6FD5}" type="datetimeFigureOut">
              <a:rPr lang="en-US" smtClean="0"/>
              <a:pPr/>
              <a:t>4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27ECF-7177-4476-A5A5-B01210BFE3C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73681-D65B-4678-B6AC-8D971C9B6FD5}" type="datetimeFigureOut">
              <a:rPr lang="en-US" smtClean="0"/>
              <a:pPr/>
              <a:t>4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27ECF-7177-4476-A5A5-B01210BFE3C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73681-D65B-4678-B6AC-8D971C9B6FD5}" type="datetimeFigureOut">
              <a:rPr lang="en-US" smtClean="0"/>
              <a:pPr/>
              <a:t>4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27ECF-7177-4476-A5A5-B01210BFE3C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73681-D65B-4678-B6AC-8D971C9B6FD5}" type="datetimeFigureOut">
              <a:rPr lang="en-US" smtClean="0"/>
              <a:pPr/>
              <a:t>4/27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27ECF-7177-4476-A5A5-B01210BFE3C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73681-D65B-4678-B6AC-8D971C9B6FD5}" type="datetimeFigureOut">
              <a:rPr lang="en-US" smtClean="0"/>
              <a:pPr/>
              <a:t>4/27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27ECF-7177-4476-A5A5-B01210BFE3C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73681-D65B-4678-B6AC-8D971C9B6FD5}" type="datetimeFigureOut">
              <a:rPr lang="en-US" smtClean="0"/>
              <a:pPr/>
              <a:t>4/27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27ECF-7177-4476-A5A5-B01210BFE3C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73681-D65B-4678-B6AC-8D971C9B6FD5}" type="datetimeFigureOut">
              <a:rPr lang="en-US" smtClean="0"/>
              <a:pPr/>
              <a:t>4/27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27ECF-7177-4476-A5A5-B01210BFE3C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73681-D65B-4678-B6AC-8D971C9B6FD5}" type="datetimeFigureOut">
              <a:rPr lang="en-US" smtClean="0"/>
              <a:pPr/>
              <a:t>4/27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27ECF-7177-4476-A5A5-B01210BFE3C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73681-D65B-4678-B6AC-8D971C9B6FD5}" type="datetimeFigureOut">
              <a:rPr lang="en-US" smtClean="0"/>
              <a:pPr/>
              <a:t>4/27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27ECF-7177-4476-A5A5-B01210BFE3C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73681-D65B-4678-B6AC-8D971C9B6FD5}" type="datetimeFigureOut">
              <a:rPr lang="en-US" smtClean="0"/>
              <a:pPr/>
              <a:t>4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927ECF-7177-4476-A5A5-B01210BFE3C7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chematic for exposure 2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62000" y="457200"/>
            <a:ext cx="7630668" cy="523595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6200" y="6019800"/>
            <a:ext cx="89772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l Figure 1</a:t>
            </a:r>
            <a:r>
              <a:rPr lang="en-US" dirty="0" smtClean="0"/>
              <a:t>. Schematic diagram for the whole-body inhalational exposure  protocol</a:t>
            </a:r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12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OSUM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xu16</dc:creator>
  <cp:lastModifiedBy>xu16</cp:lastModifiedBy>
  <cp:revision>8</cp:revision>
  <dcterms:created xsi:type="dcterms:W3CDTF">2012-04-27T13:59:14Z</dcterms:created>
  <dcterms:modified xsi:type="dcterms:W3CDTF">2012-04-27T17:36:03Z</dcterms:modified>
</cp:coreProperties>
</file>